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8" r:id="rId3"/>
    <p:sldId id="259" r:id="rId4"/>
    <p:sldId id="261" r:id="rId5"/>
    <p:sldId id="260" r:id="rId6"/>
    <p:sldId id="262" r:id="rId7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28" autoAdjust="0"/>
  </p:normalViewPr>
  <p:slideViewPr>
    <p:cSldViewPr>
      <p:cViewPr varScale="1">
        <p:scale>
          <a:sx n="75" d="100"/>
          <a:sy n="75" d="100"/>
        </p:scale>
        <p:origin x="1476" y="6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eabos.CISA\Documents\TWEAK\ELISPOT%20SANGRE%20Y%20RI&#209;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SUPLEMENTARIA ELISPOT'!$G$12:$G$14</c:f>
                <c:numCache>
                  <c:formatCode>General</c:formatCode>
                  <c:ptCount val="3"/>
                  <c:pt idx="0">
                    <c:v>46.7280020206247</c:v>
                  </c:pt>
                  <c:pt idx="1">
                    <c:v>74.513897949673293</c:v>
                  </c:pt>
                  <c:pt idx="2">
                    <c:v>34.0076244174527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LEMENTARIA ELISPOT'!$B$12:$B$14</c:f>
              <c:strCache>
                <c:ptCount val="3"/>
                <c:pt idx="0">
                  <c:v>Control</c:v>
                </c:pt>
                <c:pt idx="1">
                  <c:v>TWEAK 1 µg/ml</c:v>
                </c:pt>
                <c:pt idx="2">
                  <c:v>Irrelevant protein</c:v>
                </c:pt>
              </c:strCache>
            </c:strRef>
          </c:cat>
          <c:val>
            <c:numRef>
              <c:f>'SUPLEMENTARIA ELISPOT'!$F$12:$F$14</c:f>
              <c:numCache>
                <c:formatCode>General</c:formatCode>
                <c:ptCount val="3"/>
                <c:pt idx="0">
                  <c:v>103.77777777777777</c:v>
                </c:pt>
                <c:pt idx="1">
                  <c:v>194.2222222222222</c:v>
                </c:pt>
                <c:pt idx="2">
                  <c:v>135.333333333333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2E5-4005-B1D5-68078A32A2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0420840"/>
        <c:axId val="410416136"/>
      </c:barChart>
      <c:catAx>
        <c:axId val="4104208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1560000"/>
          <a:lstStyle/>
          <a:p>
            <a:pPr>
              <a:defRPr sz="105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410416136"/>
        <c:crosses val="autoZero"/>
        <c:auto val="1"/>
        <c:lblAlgn val="ctr"/>
        <c:lblOffset val="100"/>
        <c:noMultiLvlLbl val="0"/>
      </c:catAx>
      <c:valAx>
        <c:axId val="410416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4104208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8728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0428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34962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2327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7120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1000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1602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0720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7332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507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1697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830ED-6DA8-4FCD-B955-4D8B8D8E1FFD}" type="datetimeFigureOut">
              <a:rPr lang="es-ES" smtClean="0"/>
              <a:pPr/>
              <a:t>10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F06A1C-856D-452E-9D64-ACC868F7B7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6693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CuadroTexto"/>
          <p:cNvSpPr txBox="1"/>
          <p:nvPr/>
        </p:nvSpPr>
        <p:spPr>
          <a:xfrm>
            <a:off x="0" y="0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7 Rectángulo"/>
          <p:cNvSpPr/>
          <p:nvPr/>
        </p:nvSpPr>
        <p:spPr>
          <a:xfrm>
            <a:off x="422527" y="4341167"/>
            <a:ext cx="554461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(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SIPRED</a:t>
            </a:r>
            <a:r>
              <a:rPr lang="en-US" sz="1200" dirty="0"/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ing extracellular regions as well as signal peptide and potential regions involved in membrane interaction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Extracellular region fro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EAK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protein sequence recombinantly expressed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ighlighted in red is the His-tag and the stop codon.</a:t>
            </a:r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4718" y="3250868"/>
            <a:ext cx="5402580" cy="432816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xmlns="" id="{E08E3478-7A10-4ABF-A9F8-07AA3AC1E7F0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7" y="512362"/>
            <a:ext cx="5724356" cy="1905288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xmlns="" id="{A7EC3190-0C53-44BD-A9A1-2795B873CD63}"/>
              </a:ext>
            </a:extLst>
          </p:cNvPr>
          <p:cNvSpPr txBox="1"/>
          <p:nvPr/>
        </p:nvSpPr>
        <p:spPr>
          <a:xfrm>
            <a:off x="152637" y="461665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xmlns="" id="{E21DD21B-C03A-45DB-9FB7-A775E31BC1D8}"/>
              </a:ext>
            </a:extLst>
          </p:cNvPr>
          <p:cNvSpPr txBox="1"/>
          <p:nvPr/>
        </p:nvSpPr>
        <p:spPr>
          <a:xfrm>
            <a:off x="152637" y="2870548"/>
            <a:ext cx="288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888528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7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52" r="43572" b="51147"/>
          <a:stretch/>
        </p:blipFill>
        <p:spPr bwMode="auto">
          <a:xfrm>
            <a:off x="1352643" y="1031733"/>
            <a:ext cx="2178289" cy="20882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5896"/>
          <a:stretch>
            <a:fillRect/>
          </a:stretch>
        </p:blipFill>
        <p:spPr bwMode="auto">
          <a:xfrm>
            <a:off x="4285217" y="766053"/>
            <a:ext cx="2209063" cy="2149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412" b="33745"/>
          <a:stretch>
            <a:fillRect/>
          </a:stretch>
        </p:blipFill>
        <p:spPr bwMode="auto">
          <a:xfrm>
            <a:off x="4293096" y="3418356"/>
            <a:ext cx="2209063" cy="1944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255" b="2902"/>
          <a:stretch>
            <a:fillRect/>
          </a:stretch>
        </p:blipFill>
        <p:spPr bwMode="auto">
          <a:xfrm>
            <a:off x="4293096" y="5770870"/>
            <a:ext cx="2209063" cy="1944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709" r="43572" b="2590"/>
          <a:stretch/>
        </p:blipFill>
        <p:spPr bwMode="auto">
          <a:xfrm>
            <a:off x="1340768" y="4355976"/>
            <a:ext cx="2178289" cy="20882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" name="4 Conector recto de flecha"/>
          <p:cNvCxnSpPr/>
          <p:nvPr/>
        </p:nvCxnSpPr>
        <p:spPr>
          <a:xfrm>
            <a:off x="2889319" y="1918821"/>
            <a:ext cx="1125126" cy="2332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6 CuadroTexto"/>
          <p:cNvSpPr txBox="1"/>
          <p:nvPr/>
        </p:nvSpPr>
        <p:spPr>
          <a:xfrm rot="16200000">
            <a:off x="3848793" y="1796848"/>
            <a:ext cx="792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err="1" smtClean="0">
                <a:latin typeface="Arial" pitchFamily="34" charset="0"/>
                <a:cs typeface="Arial" pitchFamily="34" charset="0"/>
              </a:rPr>
              <a:t>IgM</a:t>
            </a:r>
            <a:endParaRPr lang="es-E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24 CuadroTexto"/>
          <p:cNvSpPr txBox="1"/>
          <p:nvPr/>
        </p:nvSpPr>
        <p:spPr>
          <a:xfrm rot="16200000">
            <a:off x="855325" y="1933168"/>
            <a:ext cx="792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itchFamily="34" charset="0"/>
                <a:cs typeface="Arial" pitchFamily="34" charset="0"/>
              </a:rPr>
              <a:t>S</a:t>
            </a:r>
            <a:r>
              <a:rPr lang="es-ES" sz="1100" b="1" dirty="0" smtClean="0">
                <a:latin typeface="Arial" pitchFamily="34" charset="0"/>
                <a:cs typeface="Arial" pitchFamily="34" charset="0"/>
              </a:rPr>
              <a:t>SC-A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27 CuadroTexto"/>
          <p:cNvSpPr txBox="1"/>
          <p:nvPr/>
        </p:nvSpPr>
        <p:spPr>
          <a:xfrm rot="16200000">
            <a:off x="855325" y="5306800"/>
            <a:ext cx="792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 err="1" smtClean="0">
                <a:latin typeface="Arial" pitchFamily="34" charset="0"/>
                <a:cs typeface="Arial" pitchFamily="34" charset="0"/>
              </a:rPr>
              <a:t>IgM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34 CuadroTexto"/>
          <p:cNvSpPr txBox="1"/>
          <p:nvPr/>
        </p:nvSpPr>
        <p:spPr>
          <a:xfrm rot="16200000">
            <a:off x="3848793" y="4242844"/>
            <a:ext cx="792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err="1" smtClean="0">
                <a:latin typeface="Arial" pitchFamily="34" charset="0"/>
                <a:cs typeface="Arial" pitchFamily="34" charset="0"/>
              </a:rPr>
              <a:t>IgM</a:t>
            </a:r>
            <a:endParaRPr lang="es-E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35 CuadroTexto"/>
          <p:cNvSpPr txBox="1"/>
          <p:nvPr/>
        </p:nvSpPr>
        <p:spPr>
          <a:xfrm rot="16200000">
            <a:off x="3848793" y="6594600"/>
            <a:ext cx="792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err="1" smtClean="0">
                <a:latin typeface="Arial" pitchFamily="34" charset="0"/>
                <a:cs typeface="Arial" pitchFamily="34" charset="0"/>
              </a:rPr>
              <a:t>IgM</a:t>
            </a:r>
            <a:endParaRPr lang="es-E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36 CuadroTexto"/>
          <p:cNvSpPr txBox="1"/>
          <p:nvPr/>
        </p:nvSpPr>
        <p:spPr>
          <a:xfrm>
            <a:off x="5085184" y="7621242"/>
            <a:ext cx="792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smtClean="0">
                <a:latin typeface="Arial" pitchFamily="34" charset="0"/>
                <a:cs typeface="Arial" pitchFamily="34" charset="0"/>
              </a:rPr>
              <a:t>FSC-A</a:t>
            </a:r>
            <a:endParaRPr lang="es-E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37 CuadroTexto"/>
          <p:cNvSpPr txBox="1"/>
          <p:nvPr/>
        </p:nvSpPr>
        <p:spPr>
          <a:xfrm>
            <a:off x="2047456" y="6407825"/>
            <a:ext cx="792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 smtClean="0">
                <a:latin typeface="Arial" pitchFamily="34" charset="0"/>
                <a:cs typeface="Arial" pitchFamily="34" charset="0"/>
              </a:rPr>
              <a:t>FSC-A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38 CuadroTexto"/>
          <p:cNvSpPr txBox="1"/>
          <p:nvPr/>
        </p:nvSpPr>
        <p:spPr>
          <a:xfrm>
            <a:off x="4532957" y="2237810"/>
            <a:ext cx="792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98.7%</a:t>
            </a:r>
            <a:endParaRPr lang="es-ES" sz="1200" b="1" dirty="0"/>
          </a:p>
        </p:txBody>
      </p:sp>
      <p:sp>
        <p:nvSpPr>
          <p:cNvPr id="40" name="39 CuadroTexto"/>
          <p:cNvSpPr txBox="1"/>
          <p:nvPr/>
        </p:nvSpPr>
        <p:spPr>
          <a:xfrm>
            <a:off x="5605898" y="4161180"/>
            <a:ext cx="792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96.9%</a:t>
            </a:r>
            <a:endParaRPr lang="es-ES" sz="1200" b="1" dirty="0"/>
          </a:p>
        </p:txBody>
      </p:sp>
      <p:sp>
        <p:nvSpPr>
          <p:cNvPr id="41" name="40 CuadroTexto"/>
          <p:cNvSpPr txBox="1"/>
          <p:nvPr/>
        </p:nvSpPr>
        <p:spPr>
          <a:xfrm>
            <a:off x="5594023" y="7057156"/>
            <a:ext cx="792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98.8%</a:t>
            </a:r>
            <a:endParaRPr lang="es-ES" sz="1200" b="1" dirty="0"/>
          </a:p>
        </p:txBody>
      </p:sp>
      <p:sp>
        <p:nvSpPr>
          <p:cNvPr id="43" name="42 CuadroTexto"/>
          <p:cNvSpPr txBox="1"/>
          <p:nvPr/>
        </p:nvSpPr>
        <p:spPr>
          <a:xfrm>
            <a:off x="4658735" y="838648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Myeloid</a:t>
            </a:r>
            <a:r>
              <a:rPr lang="es-E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cells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CuadroTexto 13"/>
          <p:cNvSpPr txBox="1"/>
          <p:nvPr/>
        </p:nvSpPr>
        <p:spPr>
          <a:xfrm>
            <a:off x="430931" y="8244408"/>
            <a:ext cx="62000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rting strategy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HK leukocyt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tal myeloid cells and IgM</a:t>
            </a:r>
            <a:r>
              <a:rPr lang="en-GB" sz="12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IgM</a:t>
            </a:r>
            <a:r>
              <a:rPr lang="en-GB" sz="12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ymphoid cells were sorted  in a </a:t>
            </a:r>
            <a:r>
              <a:rPr lang="en-GB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CSAria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II sorter. Right dot plots show the purity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sorted populations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42 CuadroTexto"/>
          <p:cNvSpPr txBox="1"/>
          <p:nvPr/>
        </p:nvSpPr>
        <p:spPr>
          <a:xfrm>
            <a:off x="4670553" y="3248990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IgM</a:t>
            </a:r>
            <a:r>
              <a:rPr lang="es-ES" sz="1200" b="1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s-ES" sz="1200" b="1" dirty="0" smtClean="0">
                <a:latin typeface="Arial" pitchFamily="34" charset="0"/>
                <a:cs typeface="Arial" pitchFamily="34" charset="0"/>
              </a:rPr>
              <a:t> B </a:t>
            </a:r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cells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42 CuadroTexto"/>
          <p:cNvSpPr txBox="1"/>
          <p:nvPr/>
        </p:nvSpPr>
        <p:spPr>
          <a:xfrm>
            <a:off x="4658735" y="5601504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IgM</a:t>
            </a:r>
            <a:r>
              <a:rPr lang="es-ES" sz="1200" b="1" baseline="300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s-E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lymphoid</a:t>
            </a:r>
            <a:r>
              <a:rPr lang="es-E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cells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28 CuadroTexto"/>
          <p:cNvSpPr txBox="1"/>
          <p:nvPr/>
        </p:nvSpPr>
        <p:spPr>
          <a:xfrm>
            <a:off x="5085184" y="5266814"/>
            <a:ext cx="792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smtClean="0">
                <a:latin typeface="Arial" pitchFamily="34" charset="0"/>
                <a:cs typeface="Arial" pitchFamily="34" charset="0"/>
              </a:rPr>
              <a:t>FSC-A</a:t>
            </a:r>
            <a:endParaRPr lang="es-E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29 CuadroTexto"/>
          <p:cNvSpPr txBox="1"/>
          <p:nvPr/>
        </p:nvSpPr>
        <p:spPr>
          <a:xfrm>
            <a:off x="5085184" y="2869074"/>
            <a:ext cx="792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smtClean="0">
                <a:latin typeface="Arial" pitchFamily="34" charset="0"/>
                <a:cs typeface="Arial" pitchFamily="34" charset="0"/>
              </a:rPr>
              <a:t>FSC-A</a:t>
            </a:r>
            <a:endParaRPr lang="es-E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" name="33 Conector recto de flecha"/>
          <p:cNvCxnSpPr/>
          <p:nvPr/>
        </p:nvCxnSpPr>
        <p:spPr>
          <a:xfrm>
            <a:off x="2132856" y="2783675"/>
            <a:ext cx="0" cy="1584176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45 Conector recto de flecha"/>
          <p:cNvCxnSpPr/>
          <p:nvPr/>
        </p:nvCxnSpPr>
        <p:spPr>
          <a:xfrm>
            <a:off x="2934325" y="5975538"/>
            <a:ext cx="1080120" cy="684694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47 Conector recto de flecha"/>
          <p:cNvCxnSpPr/>
          <p:nvPr/>
        </p:nvCxnSpPr>
        <p:spPr>
          <a:xfrm flipV="1">
            <a:off x="2934325" y="4427984"/>
            <a:ext cx="1080120" cy="720080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49 CuadroTexto"/>
          <p:cNvSpPr txBox="1"/>
          <p:nvPr/>
        </p:nvSpPr>
        <p:spPr>
          <a:xfrm>
            <a:off x="2048973" y="3059832"/>
            <a:ext cx="792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 smtClean="0">
                <a:latin typeface="Arial" pitchFamily="34" charset="0"/>
                <a:cs typeface="Arial" pitchFamily="34" charset="0"/>
              </a:rPr>
              <a:t>FSC-A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1 CuadroTexto"/>
          <p:cNvSpPr txBox="1"/>
          <p:nvPr/>
        </p:nvSpPr>
        <p:spPr>
          <a:xfrm>
            <a:off x="0" y="0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66991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006" y="827584"/>
            <a:ext cx="6326684" cy="20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3 CuadroTexto"/>
          <p:cNvSpPr txBox="1"/>
          <p:nvPr/>
        </p:nvSpPr>
        <p:spPr>
          <a:xfrm rot="16200000">
            <a:off x="2040948" y="1631244"/>
            <a:ext cx="7432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5" name="4 CuadroTexto"/>
          <p:cNvSpPr txBox="1"/>
          <p:nvPr/>
        </p:nvSpPr>
        <p:spPr>
          <a:xfrm rot="16200000">
            <a:off x="-119287" y="1642128"/>
            <a:ext cx="721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1119872" y="2869026"/>
            <a:ext cx="12591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7" name="6 CuadroTexto"/>
          <p:cNvSpPr txBox="1"/>
          <p:nvPr/>
        </p:nvSpPr>
        <p:spPr>
          <a:xfrm>
            <a:off x="3265918" y="2869026"/>
            <a:ext cx="8054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8" name="7 CuadroTexto"/>
          <p:cNvSpPr txBox="1"/>
          <p:nvPr/>
        </p:nvSpPr>
        <p:spPr>
          <a:xfrm>
            <a:off x="3405301" y="1492309"/>
            <a:ext cx="697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inglets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5440085" y="2869026"/>
            <a:ext cx="6665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0" name="9 CuadroTexto"/>
          <p:cNvSpPr txBox="1"/>
          <p:nvPr/>
        </p:nvSpPr>
        <p:spPr>
          <a:xfrm rot="16200000">
            <a:off x="4182181" y="1599440"/>
            <a:ext cx="7432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11" name="10 CuadroTexto"/>
          <p:cNvSpPr txBox="1"/>
          <p:nvPr/>
        </p:nvSpPr>
        <p:spPr>
          <a:xfrm>
            <a:off x="5564541" y="1882121"/>
            <a:ext cx="8969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Living </a:t>
            </a:r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uadroTexto 13"/>
          <p:cNvSpPr txBox="1"/>
          <p:nvPr/>
        </p:nvSpPr>
        <p:spPr>
          <a:xfrm>
            <a:off x="307678" y="3360849"/>
            <a:ext cx="620000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ow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tometry gating strategy for HK leukocytes. For each sample, FSC/SSC profiles were used to define lymphoid gates. Single cells were identified by plotting FSC-H/FSC-A profiles. </a:t>
            </a:r>
            <a:r>
              <a:rPr lang="es-E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PI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criminat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v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a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I n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gative cells within the singlet gate were used in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 experiments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E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5" name="1 CuadroTexto"/>
          <p:cNvSpPr txBox="1"/>
          <p:nvPr/>
        </p:nvSpPr>
        <p:spPr>
          <a:xfrm>
            <a:off x="0" y="0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92055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7 Rectángulo"/>
          <p:cNvSpPr/>
          <p:nvPr/>
        </p:nvSpPr>
        <p:spPr>
          <a:xfrm>
            <a:off x="116632" y="7708619"/>
            <a:ext cx="6655421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4. (A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irwise sequence alignment of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corhynchus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ykiss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EAK proteins. The amino acids conserved between both proteins are marked in dark blue and are also represented as full yellow bars in the conservation legend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tree showing the relationships among TNFSF12 amino acid sequences from different species and classes. The tree was constructed using the maximum likelihood algorithm in MEGA X software and the analysis reliability was assessed by 1000 bootstrap replicates. A protein homologue to TNFSF12 identified in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anchiostoma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ridae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included as an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utgrou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used for rooting purpos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664" y="496631"/>
            <a:ext cx="5612124" cy="7048610"/>
          </a:xfrm>
          <a:prstGeom prst="rect">
            <a:avLst/>
          </a:prstGeom>
        </p:spPr>
      </p:pic>
      <p:sp>
        <p:nvSpPr>
          <p:cNvPr id="6" name="1 CuadroTexto"/>
          <p:cNvSpPr txBox="1"/>
          <p:nvPr/>
        </p:nvSpPr>
        <p:spPr>
          <a:xfrm>
            <a:off x="0" y="0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08351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0124101"/>
              </p:ext>
            </p:extLst>
          </p:nvPr>
        </p:nvGraphicFramePr>
        <p:xfrm>
          <a:off x="789863" y="871268"/>
          <a:ext cx="2488175" cy="30704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6 CuadroTexto"/>
          <p:cNvSpPr txBox="1"/>
          <p:nvPr/>
        </p:nvSpPr>
        <p:spPr>
          <a:xfrm>
            <a:off x="1625234" y="892814"/>
            <a:ext cx="4146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" name="3 CuadroTexto"/>
          <p:cNvSpPr txBox="1"/>
          <p:nvPr/>
        </p:nvSpPr>
        <p:spPr>
          <a:xfrm rot="16200000">
            <a:off x="-492084" y="1652606"/>
            <a:ext cx="21526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pot </a:t>
            </a:r>
            <a:r>
              <a:rPr lang="es-E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ming</a:t>
            </a:r>
            <a:r>
              <a:rPr lang="es-E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7 Rectángulo"/>
          <p:cNvSpPr/>
          <p:nvPr/>
        </p:nvSpPr>
        <p:spPr>
          <a:xfrm>
            <a:off x="161924" y="3959989"/>
            <a:ext cx="658177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ISpo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IgM-secreting cells from HK leukocytes cultured in the presence or absence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EAK 1 (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g/ml) and an irrelevant protein at the same concentration during 72 h. Results are shown as the mean number of spot form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in each wel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ean + SD; n=3 independent fish). Asterisks denote significantly different values among groups as indica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*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8 Conector recto"/>
          <p:cNvCxnSpPr/>
          <p:nvPr/>
        </p:nvCxnSpPr>
        <p:spPr>
          <a:xfrm>
            <a:off x="1354238" y="1131541"/>
            <a:ext cx="8107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6 CuadroTexto"/>
          <p:cNvSpPr txBox="1"/>
          <p:nvPr/>
        </p:nvSpPr>
        <p:spPr>
          <a:xfrm>
            <a:off x="2483690" y="892814"/>
            <a:ext cx="4146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1" name="10 Conector recto"/>
          <p:cNvCxnSpPr/>
          <p:nvPr/>
        </p:nvCxnSpPr>
        <p:spPr>
          <a:xfrm>
            <a:off x="2212694" y="1131541"/>
            <a:ext cx="8107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11 CuadroTexto"/>
          <p:cNvSpPr txBox="1"/>
          <p:nvPr/>
        </p:nvSpPr>
        <p:spPr>
          <a:xfrm>
            <a:off x="0" y="0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99265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11 CuadroTexto"/>
          <p:cNvSpPr txBox="1"/>
          <p:nvPr/>
        </p:nvSpPr>
        <p:spPr>
          <a:xfrm>
            <a:off x="14427" y="0"/>
            <a:ext cx="9071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ángulo 3"/>
          <p:cNvSpPr/>
          <p:nvPr/>
        </p:nvSpPr>
        <p:spPr>
          <a:xfrm>
            <a:off x="467981" y="6998068"/>
            <a:ext cx="4882852" cy="30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st of primers used to evaluate gene transcription.</a:t>
            </a:r>
            <a:endParaRPr lang="es-E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a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1774290"/>
              </p:ext>
            </p:extLst>
          </p:nvPr>
        </p:nvGraphicFramePr>
        <p:xfrm>
          <a:off x="487344" y="899592"/>
          <a:ext cx="5537200" cy="5798185"/>
        </p:xfrm>
        <a:graphic>
          <a:graphicData uri="http://schemas.openxmlformats.org/drawingml/2006/table">
            <a:tbl>
              <a:tblPr firstRow="1" firstCol="1" bandRow="1"/>
              <a:tblGrid>
                <a:gridCol w="1117600">
                  <a:extLst>
                    <a:ext uri="{9D8B030D-6E8A-4147-A177-3AD203B41FA5}">
                      <a16:colId xmlns:a16="http://schemas.microsoft.com/office/drawing/2014/main" xmlns="" val="497604205"/>
                    </a:ext>
                  </a:extLst>
                </a:gridCol>
                <a:gridCol w="2264410">
                  <a:extLst>
                    <a:ext uri="{9D8B030D-6E8A-4147-A177-3AD203B41FA5}">
                      <a16:colId xmlns:a16="http://schemas.microsoft.com/office/drawing/2014/main" xmlns="" val="4207056279"/>
                    </a:ext>
                  </a:extLst>
                </a:gridCol>
                <a:gridCol w="2155190">
                  <a:extLst>
                    <a:ext uri="{9D8B030D-6E8A-4147-A177-3AD203B41FA5}">
                      <a16:colId xmlns:a16="http://schemas.microsoft.com/office/drawing/2014/main" xmlns="" val="1118694452"/>
                    </a:ext>
                  </a:extLst>
                </a:gridCol>
              </a:tblGrid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ward primer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verse primer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17777227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F-1α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TCCAGAAGGAGGTCACC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TACGTTCGACCTTCCATCC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76860733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WEAK 1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TTTTCAAAGACAGAAACTACAAGG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ATCTTCAAAGAAGCAGGGGTAG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16429593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WEAK 2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AAGGAAATAAATGGAGCGGT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AGGCTGGTGGGAGGAG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3756289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NF-α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ACACACTGGGCTCTTCT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CCGAATAGCGCCAAATA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35695751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-1β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CATGGTGCGTTTCCTTT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CGGTTTGGTGTAGTCCTG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34015887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-6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TTGCGGAACCAACAGTTTG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TCAGCAACCTTCATCTGGTC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89982159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-8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TGAGACGGAAAGCAGACG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TGCTCAGAGTGGCAATG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68713007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N-</a:t>
                      </a: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γ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AGGCTCTGTCCGAGTTC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TGTGATTTGAGCCTCTGG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19390201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κ-Bα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AAAATGATACCTAGCCAAGAAG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TTCATTACTGCAGGAGTTTGAC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21786725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CGTGTTTGAGAACAAAGC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CGGCTCGATGATCGTAA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05583821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CATCACCTGGCACATCA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TCAGGTTGCCCTTTGATTC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57804458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D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CTACATGGGAGTCAGTCAAC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TCGATCCTACCTCCAGTTCC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39028359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TGCTCATCCACAGCCTA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TCTCCTGGCTGTCTGACC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33342165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8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TCGTGCAAAGTGGGAAAG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TTGCAATGGCATACAGTG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26900017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helicidin 1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CAGCTCCAAGTCAAGACTTTGA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TCCGAATCTTCTGCTGCA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19426100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helicidin 2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ATGGAGGCAGAAGTTCAGAAG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GCCAAACCCAGGACGAG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87799051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epcidin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TGTTCCTTTCTCCGAGGTGC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GACAGCAGTTGCAGCACC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05016182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creted IgM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CAAGAGGGAGACCGGAGGAG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TCCTGATTGAATCTGGCTAGTGG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9743596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limp1a-1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GCGCCCCAGTCAAGAT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GGGTAGAGGGCACAGC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03709423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limp1a-2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TCGGCCCTATGTGTGG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CATAGCCAGGATGCAGAGG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1060768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limp1c-1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ACTGCATCAACACCGAGA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GGTCTCCATCACCATCT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09342635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limp1c-2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CCAATGGGAATATGTCACT</a:t>
                      </a:r>
                      <a:endParaRPr lang="es-ES" sz="11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CATAGCCAGGATGCAGAGG</a:t>
                      </a:r>
                      <a:endParaRPr lang="es-ES" sz="11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811370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480790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2</TotalTime>
  <Words>474</Words>
  <Application>Microsoft Office PowerPoint</Application>
  <PresentationFormat>Presentación en pantalla (4:3)</PresentationFormat>
  <Paragraphs>112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stefanía Muñoz Atienza</dc:creator>
  <cp:lastModifiedBy>Carolina Tafalla</cp:lastModifiedBy>
  <cp:revision>40</cp:revision>
  <dcterms:created xsi:type="dcterms:W3CDTF">2021-05-20T11:24:33Z</dcterms:created>
  <dcterms:modified xsi:type="dcterms:W3CDTF">2021-09-10T11:58:02Z</dcterms:modified>
</cp:coreProperties>
</file>